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(null)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4"/>
  </p:normalViewPr>
  <p:slideViewPr>
    <p:cSldViewPr snapToGrid="0" snapToObjects="1">
      <p:cViewPr>
        <p:scale>
          <a:sx n="95" d="100"/>
          <a:sy n="95" d="100"/>
        </p:scale>
        <p:origin x="552" y="8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CADAD-8FDA-F249-8EE4-C6EDFD5810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C677F5-2419-3D40-BE37-DE9696E736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5F73F-7FCD-6748-BC8F-A6B063C2F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D85DF0-1B97-4344-AD4D-4279C52E3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0AE722-5498-7945-BF39-A763F8429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753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06B773-22A7-A046-A497-D314460D15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DC8E7A-EDAF-EC46-BC7D-A0FCD16D84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5542B2-1F8D-7C4F-820E-BC6DAE9AA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7B0B03-0E01-364F-8544-D63F652AB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BBED36-FF83-A349-9492-BD703F7F1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80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13C6CB-BB5B-8049-9701-83C635FEF0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1AA2C4-2D9E-CB40-B756-072E620B5C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643DC-A32B-9D4C-91C2-84B185046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0F7A48-C47E-A143-A6AB-9393DD20B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4FBAD0-43BF-6143-A5F4-1BA3CAF58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805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7102A-4B35-924A-87F3-1456943455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C6678B-61F2-9546-9172-E225CF18C1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5B7A8-CE55-C346-9144-8259EBDA9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3FD75D-009D-4148-A1A4-F8563E4A8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E9BA59-9CA1-6043-8E49-4B0797774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349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EFD3B8-A3BD-7E44-AF09-455B3C7590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7C254A-08B0-F44E-8183-B7ED857B30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CE82FB-21C5-AA4C-9EDF-B9024F19E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CDB83D-2EFA-BD48-B66B-74BE0F568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27DBBC-63E9-D541-8EA8-15F0C0CFF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03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48A38A-BD1D-E847-9731-57AACC159C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CC08F2-5B30-B548-ABC7-FCC86EF0DC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6649F8-2BB1-B44A-9FCD-CE3915AD0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644888-7C34-9647-BEC1-48AEAB36F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9107F4-B4B9-424A-B998-63D21B58B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746165-AF35-704C-8D00-523DA83B2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286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08DBF-A840-3249-AAD9-CC03ACCF95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C7B7C7-1297-4744-81AB-BE85AF9563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DD47A8-2587-804A-9F9B-4424644B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43154A-B043-4349-95FE-B8A1B1F986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AABFE3-8BEA-6F42-9F85-5C11BA7502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DD54D5-9656-1747-B97D-0A0B41FD8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6139BE-1BCE-9043-A1BB-05530197F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CC8CDCF-9070-F447-B780-8AD956596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732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971AAA-A72F-B348-B229-58F8627B8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A2CAA9-69D7-FE4E-B6BA-35B19F719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9186FE-17E7-BD42-B712-891750736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17D176-0118-8247-AE60-BF6F3DC23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833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35FAC3-0A60-B648-889A-F2A4ADD0E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571858-3853-6E4A-9225-6B6BBCD7D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02A38C9-3F0F-F74F-A480-8B2E76B24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346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BF408A-D0B5-AE42-93C9-84B731CB9D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CD3100-95D2-7943-9616-F4C97603B8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0A5C75-DF2D-5343-AFB4-0F17ED7F1F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E36171-0C69-1C47-A4D6-2FACD7366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6A722C-1B8A-2B4B-8AC1-D5D9B03A7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2FA1DD-FCBA-E64D-A2A0-3DED5E5D5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46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54C344-033C-974A-B31C-624F32C5E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BD7838-D2B8-8841-A5F3-66ABB93BC9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5F9DEA-4E4B-AB42-BF76-A8BE56583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D2AC8F-059A-E24A-9893-051449A83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C305A6-45AD-2B4D-9813-147778AD9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2C7171-C9EA-6840-A683-760E6250D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238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79FDD0-1641-834B-AE8A-0961447DD1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DE37D4-E78C-CE4B-B800-2C8D468470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100F66-905D-EB4F-850B-412CDC393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6992D-2945-E54C-BBF0-1FE08B154A4C}" type="datetimeFigureOut">
              <a:rPr lang="en-US" smtClean="0"/>
              <a:t>1/29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CDBFB2-B2BF-0945-980A-7CED2B9C0A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18924E-C48A-3E4A-B2AC-3CCC3386D1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D4589-A33F-214E-B34A-0E6C42984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931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(null)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(null)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(null)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(null)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(null)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(null)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(null)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(null)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(null)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(null)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(null)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(null)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C620182-CF1E-4F42-8888-FABE2929142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206" b="29546"/>
          <a:stretch/>
        </p:blipFill>
        <p:spPr>
          <a:xfrm>
            <a:off x="1448763" y="914401"/>
            <a:ext cx="8798690" cy="305192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674D70F-84B7-F940-BE53-C98D6D397D4F}"/>
              </a:ext>
            </a:extLst>
          </p:cNvPr>
          <p:cNvSpPr/>
          <p:nvPr/>
        </p:nvSpPr>
        <p:spPr>
          <a:xfrm>
            <a:off x="520861" y="4290420"/>
            <a:ext cx="11435786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1.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E. </a:t>
            </a:r>
            <a:r>
              <a:rPr lang="en-US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but not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kills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endParaRPr lang="en-US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Late L4 larval N2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, in the absence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(A)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or presence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(B)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of sterilizing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cdc-25.1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feeding RNAi, were infected with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strain MMH594 or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strain E007. Each graph shows the average of three plates for each strain, with each plate containing 30-40 worms. Results are representative of 3 independent assays. The difference between the survival curves of each condition on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was statistically significant (p&lt;0.05), as determined by Kaplan-Meier log rank analysis.</a:t>
            </a:r>
            <a:b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62198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467F20D-B6F4-004F-A354-027FC39286C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411" b="11177"/>
          <a:stretch/>
        </p:blipFill>
        <p:spPr>
          <a:xfrm>
            <a:off x="1335740" y="121023"/>
            <a:ext cx="8937351" cy="465268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CA3B269-D29A-4741-B768-1F3D1433B591}"/>
              </a:ext>
            </a:extLst>
          </p:cNvPr>
          <p:cNvSpPr/>
          <p:nvPr/>
        </p:nvSpPr>
        <p:spPr>
          <a:xfrm>
            <a:off x="416626" y="5082988"/>
            <a:ext cx="1157814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10</a:t>
            </a:r>
            <a:r>
              <a:rPr lang="en-US" sz="1400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urvival of wild-type N2 and stress-response mutants on heat-killed 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b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</a:b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a)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Heat-map of the fold-changes of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-activated genes in N2 worms treated with RNAi against RNAi pathway components (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cr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rh-3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rsh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or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rde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.  The heat-map reflects data from 2-3 biological replicates for each mutant analyzed. 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)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Lifespan of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r-15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26);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m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hc17)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C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treated with L4440 vector control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rsh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rh-3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cr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r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rde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NAi on heat-killed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(left). Statistically significant (p&lt;0.05) survival curves relative to L4440 control are marked with an asterisk and bracket. Each graph shows the average of three plates for each strain, with each plate containing 30-40 worms. Statistical significance of differences between survival curves was calculated using Kaplan-Meier log rank analysis.</a:t>
            </a:r>
          </a:p>
        </p:txBody>
      </p:sp>
    </p:spTree>
    <p:extLst>
      <p:ext uri="{BB962C8B-B14F-4D97-AF65-F5344CB8AC3E}">
        <p14:creationId xmlns:p14="http://schemas.microsoft.com/office/powerpoint/2010/main" val="41306613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2E78EB-9167-E248-AC4F-D3C7010ED6B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313" r="13333" b="8824"/>
          <a:stretch/>
        </p:blipFill>
        <p:spPr>
          <a:xfrm>
            <a:off x="1981199" y="0"/>
            <a:ext cx="7358744" cy="489472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0093765-C7AD-0E4C-A2BC-960EB0700D97}"/>
              </a:ext>
            </a:extLst>
          </p:cNvPr>
          <p:cNvSpPr/>
          <p:nvPr/>
        </p:nvSpPr>
        <p:spPr>
          <a:xfrm>
            <a:off x="318246" y="5014934"/>
            <a:ext cx="1164515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11.</a:t>
            </a:r>
            <a:r>
              <a:rPr lang="en-US" sz="1600" b="1" dirty="0">
                <a:solidFill>
                  <a:srgbClr val="4F81BD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urvival of nuclear hormone receptor-deficient </a:t>
            </a:r>
            <a:r>
              <a:rPr lang="en-US" sz="16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6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n </a:t>
            </a:r>
            <a:r>
              <a:rPr lang="en-US" sz="16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US" sz="16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b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</a:b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a)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Lifespan of N2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68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gk708)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01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</a:t>
            </a:r>
            <a:r>
              <a:rPr lang="en-US" sz="1600" dirty="0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gk586)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14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gk849) (left) treated with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dc-25.1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NAi, or 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)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L4440 vector control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62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88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97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44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93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or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212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NAi-treated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r-15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;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m-1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worms following infection with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(left) or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(right). Each graph shows the average of three plates for each strain, with each plate containing 30-40 worms. Results are representative of 2 independent assays. Statistically significant (p&lt;0.05) survival curves relative to control are marked with an asterisk. Statistical significance of differences between survival curves was calculated using Kaplan-Meier log rank analysis.</a:t>
            </a:r>
          </a:p>
        </p:txBody>
      </p:sp>
    </p:spTree>
    <p:extLst>
      <p:ext uri="{BB962C8B-B14F-4D97-AF65-F5344CB8AC3E}">
        <p14:creationId xmlns:p14="http://schemas.microsoft.com/office/powerpoint/2010/main" val="9746364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E7C84D2-37C7-6F4E-BB26-A256CA05626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08" b="29215"/>
          <a:stretch/>
        </p:blipFill>
        <p:spPr>
          <a:xfrm>
            <a:off x="228283" y="578224"/>
            <a:ext cx="11713019" cy="361725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E37555A-0ACE-234B-AB71-3CE9CB25F33D}"/>
              </a:ext>
            </a:extLst>
          </p:cNvPr>
          <p:cNvSpPr/>
          <p:nvPr/>
        </p:nvSpPr>
        <p:spPr>
          <a:xfrm>
            <a:off x="609599" y="4550165"/>
            <a:ext cx="1095038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12.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urvival of nuclear hormone receptor mutants on heat-killed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  </a:t>
            </a:r>
          </a:p>
          <a:p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a)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Lifespan of N2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68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gk708)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0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</a:t>
            </a:r>
            <a:r>
              <a:rPr lang="en-US" dirty="0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gk586)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14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gk849) (left) treated with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dc-25.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NAi, or 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)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L4440 vector control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62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88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97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44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193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or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hr-212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NAi-treated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r-15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;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m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worms. Each graph shows the average of three plates for each strain, with each plate containing 30-40 worms. Results are representative of 2 independent assays. Relevant statistically significant survival curves are marked with an asterisk and bracket. Statistical significance of differences between survival curves was calculated using Kaplan-Meier log rank analysis.</a:t>
            </a:r>
          </a:p>
        </p:txBody>
      </p:sp>
    </p:spTree>
    <p:extLst>
      <p:ext uri="{BB962C8B-B14F-4D97-AF65-F5344CB8AC3E}">
        <p14:creationId xmlns:p14="http://schemas.microsoft.com/office/powerpoint/2010/main" val="28430068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D88D92-EC5D-0E46-A816-24EAF88B341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08" b="26863"/>
          <a:stretch/>
        </p:blipFill>
        <p:spPr>
          <a:xfrm>
            <a:off x="0" y="591669"/>
            <a:ext cx="11574163" cy="377862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801DC6B-2577-2041-ADD9-215FC39449EC}"/>
              </a:ext>
            </a:extLst>
          </p:cNvPr>
          <p:cNvSpPr/>
          <p:nvPr/>
        </p:nvSpPr>
        <p:spPr>
          <a:xfrm>
            <a:off x="341265" y="4573902"/>
            <a:ext cx="11555506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6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13.</a:t>
            </a:r>
            <a:r>
              <a:rPr lang="en-US" sz="1600" b="1" dirty="0">
                <a:solidFill>
                  <a:srgbClr val="4F81BD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re-exposure to non-</a:t>
            </a:r>
            <a:r>
              <a:rPr lang="en-US" sz="1600" b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al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bacteria does not confer resistance, and there is no evidence of transgenerational inheritance of resistance to </a:t>
            </a:r>
            <a:r>
              <a:rPr lang="en-US" sz="16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6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(a)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urvival of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r-15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26)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;fem-1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hc17) worms exposed to 8 hours of heat-killed or live bacteria (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. aureus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CTC8325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or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. subtilis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PY79) and then transferred to live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young adult N2 worms were fed either live or heat-killed bacteria (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P50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MMH594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E007,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. aureus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CTC8325, or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. subtilis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Y79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for 48 hours at 25C before the gravid worms were bleached and their eggs harvested and synchronized. The progeny were treated with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dc-25.1 RNAi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and their survival on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6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assayed. Each graph shows the average of three plates for each strain, with each plate containing 30-40 worms. Results are representative of 2 independent assays. Statistically significant (p&lt;0.05) survival curves (relative to HK </a:t>
            </a:r>
            <a:r>
              <a:rPr lang="en-US" sz="16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 are marked with asterisks. Statistical significance of differences between survival curves was calculated using Kaplan-Meier log rank analysis.</a:t>
            </a:r>
          </a:p>
        </p:txBody>
      </p:sp>
    </p:spTree>
    <p:extLst>
      <p:ext uri="{BB962C8B-B14F-4D97-AF65-F5344CB8AC3E}">
        <p14:creationId xmlns:p14="http://schemas.microsoft.com/office/powerpoint/2010/main" val="32503735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0275A52-8DCD-834B-BC67-A2A5638710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163" b="19833"/>
          <a:stretch/>
        </p:blipFill>
        <p:spPr>
          <a:xfrm>
            <a:off x="1997597" y="1193800"/>
            <a:ext cx="7498466" cy="31496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2E0A091-F811-0341-95C1-91B53ACEB8E3}"/>
              </a:ext>
            </a:extLst>
          </p:cNvPr>
          <p:cNvSpPr/>
          <p:nvPr/>
        </p:nvSpPr>
        <p:spPr>
          <a:xfrm>
            <a:off x="710556" y="4719578"/>
            <a:ext cx="1090994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2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PMK-1 is required for defense against </a:t>
            </a:r>
            <a:r>
              <a:rPr lang="en-US" b="1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b="1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b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</a:b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Survival of wild-type N2 and mutant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pmk-1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(km25)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infected with either of two different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strains, E007 and BM4105SS. </a:t>
            </a:r>
            <a:r>
              <a:rPr lang="en-US" dirty="0">
                <a:solidFill>
                  <a:srgbClr val="333333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Each graph shows the average of three plates for each strain, with each plate containing 30-40 worms. Results are representative of 3 independent assays. Statistically significant survival curves relative to N2 in each condition are marked with an asterisk and bracket.  Statistical significance of differences between survival curves was calculated using Kaplan-Meier log rank analysi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4137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2EC9B70-2349-0B46-A277-61FBE32FCD6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333" b="18148"/>
          <a:stretch/>
        </p:blipFill>
        <p:spPr>
          <a:xfrm>
            <a:off x="2565400" y="1028700"/>
            <a:ext cx="7349924" cy="32258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A9C6471-7909-2C47-BE0C-ADE81395CFAC}"/>
              </a:ext>
            </a:extLst>
          </p:cNvPr>
          <p:cNvSpPr/>
          <p:nvPr/>
        </p:nvSpPr>
        <p:spPr>
          <a:xfrm>
            <a:off x="677762" y="4737080"/>
            <a:ext cx="1113323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3.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urvival of wild-type N2,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mk-1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shr-1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ar-1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and double mutants on heat-killed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Wi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ld-type N2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mk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km25)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shr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ok778)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ar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ga80),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mk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km25);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shr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ok778) and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mk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km25);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bar-1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ga80) animals on heat-killed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at 25˚C. Each graph shows the average of three plates for each strain, with each plate containing 30-40 worms.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Results are representative of 2 independent assays. Statistically significant (p&lt;0.05) survival curves are marked with asterisks. Statistical significance of differences between survival curves (as compared to N2) was calculated using Kaplan-Meier log rank analysis.</a:t>
            </a:r>
          </a:p>
        </p:txBody>
      </p:sp>
    </p:spTree>
    <p:extLst>
      <p:ext uri="{BB962C8B-B14F-4D97-AF65-F5344CB8AC3E}">
        <p14:creationId xmlns:p14="http://schemas.microsoft.com/office/powerpoint/2010/main" val="33503282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2D38AF4-1441-4344-9A70-6DAD4D53B4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8733" y="345954"/>
            <a:ext cx="4976214" cy="489030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BF2AFCE-F0CD-E44E-BA6D-42CDA9DA06D3}"/>
              </a:ext>
            </a:extLst>
          </p:cNvPr>
          <p:cNvSpPr/>
          <p:nvPr/>
        </p:nvSpPr>
        <p:spPr>
          <a:xfrm>
            <a:off x="355600" y="5236258"/>
            <a:ext cx="117221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4</a:t>
            </a:r>
            <a:r>
              <a:rPr lang="en-US" sz="1400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he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E. </a:t>
            </a:r>
            <a:r>
              <a:rPr lang="en-US" sz="14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infection gene signature comprises genes that are pathogen-specific, as well as genes that are shared among diverse pathogens. </a:t>
            </a:r>
            <a:endParaRPr lang="en-US" sz="14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Venn diagrams comparing both th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and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infection gene signatures (relative to heat-killed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) with the infection gene signatures of (A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S. aureu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NCTC8325, (B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P. aeruginosa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PA14, and (C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albicans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DAY185 (relative to their respective controls). (D) Th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infection gene signature (relative to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) compared to the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M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nematophilum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CBX102 infection gene signature (virulent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M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nematophilum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CBX102 relative to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</a:rPr>
              <a:t>avirulent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</a:rPr>
              <a:t>M.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</a:rPr>
              <a:t>nematophilum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UV336). The number at the bottom right corner of each quadrant represents the number of annotated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</a:rPr>
              <a:t>Affymetrix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  <a:t> probes found to not be differentially expressed in either comparison.</a:t>
            </a:r>
            <a:br>
              <a:rPr lang="en-US" sz="1400" dirty="0">
                <a:latin typeface="Calibri" panose="020F0502020204030204" pitchFamily="34" charset="0"/>
                <a:ea typeface="Calibri" panose="020F0502020204030204" pitchFamily="34" charset="0"/>
              </a:rPr>
            </a:b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1824363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F3EE20C-43DF-4C49-ADC9-5DAD7BA72C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14" b="9310"/>
          <a:stretch/>
        </p:blipFill>
        <p:spPr>
          <a:xfrm>
            <a:off x="2482850" y="323736"/>
            <a:ext cx="7226300" cy="413396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3CC068C-B1EE-7E47-A519-23C149D47356}"/>
              </a:ext>
            </a:extLst>
          </p:cNvPr>
          <p:cNvSpPr/>
          <p:nvPr/>
        </p:nvSpPr>
        <p:spPr>
          <a:xfrm>
            <a:off x="527050" y="4309239"/>
            <a:ext cx="111379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5.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 Validation of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-activated genes identified in the microarray using </a:t>
            </a:r>
            <a:r>
              <a:rPr lang="en-US" b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anoString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b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Counter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analysis. </a:t>
            </a:r>
            <a:endParaRPr lang="en-US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The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NanoStrin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nCounte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system was used to validate a set of 67 genes, representing the most highly upregulated and downregulated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-activated genes. Correlation of microarray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nCounte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data was determined by plotting the average fold difference observed in the microarray analysis (three biological replicates) versus the average fold difference for the same gene obtained by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nCounte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(three biological replicates, different from the microarray samples). Linear regression analysis revealed strong correlation between the microarray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NanoStrin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datasets for both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(R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</a:rPr>
              <a:t>2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= 0.8793) and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(R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</a:rPr>
              <a:t>2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= 0.9124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65352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C0CDC42-5D23-544B-AFAC-B95F8395CDC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14" b="6373"/>
          <a:stretch/>
        </p:blipFill>
        <p:spPr>
          <a:xfrm>
            <a:off x="2174846" y="169195"/>
            <a:ext cx="7779553" cy="494851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6CDF901-A458-7141-BE77-3BEAF56D85BC}"/>
              </a:ext>
            </a:extLst>
          </p:cNvPr>
          <p:cNvSpPr/>
          <p:nvPr/>
        </p:nvSpPr>
        <p:spPr>
          <a:xfrm>
            <a:off x="255493" y="5252186"/>
            <a:ext cx="1161826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6</a:t>
            </a:r>
            <a:r>
              <a:rPr lang="en-US" sz="1200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orrelation matrix of </a:t>
            </a:r>
            <a:r>
              <a:rPr lang="en-US" sz="12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2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mutants fed either heat-killed or live </a:t>
            </a:r>
            <a:r>
              <a:rPr lang="en-US" sz="12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i. </a:t>
            </a:r>
            <a:br>
              <a:rPr lang="en-US" sz="12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</a:b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ierarchical clustering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endrograms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and a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eatmap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howing the color-coded pairwise correlation matrix for the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Counter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gene expression profiles of N2 or mutant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d either heat-killed or live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i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The correlation matrix provides a quantitative comparison of any two conditions' gene expression profiles. A correlation value of 1 indicates that the two samples compared are identical; thus, the diagonal coefficients representing the correlation of a sample with itself has a perfect positive correlation, as indicated by the red color. Hierarchical cluster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endrograms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indicate the degree of similarity between different bacterial/mutant conditions using the distance at which the branch point occurs. Mutants fed either live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r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cluster together; similarly, mutants fed either heat-killed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or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cluster together. All N2 worms, whether fed heat-killed or live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i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are closely correlated. The Pearson’s correlation coefficient for each </a:t>
            </a:r>
            <a:r>
              <a:rPr lang="en-US" sz="12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2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train and </a:t>
            </a: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al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pecies pair analyzed is shown.</a:t>
            </a:r>
          </a:p>
        </p:txBody>
      </p:sp>
    </p:spTree>
    <p:extLst>
      <p:ext uri="{BB962C8B-B14F-4D97-AF65-F5344CB8AC3E}">
        <p14:creationId xmlns:p14="http://schemas.microsoft.com/office/powerpoint/2010/main" val="28973305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29FC93E-9D50-D84E-A4F8-0DF195822B6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13" b="44510"/>
          <a:stretch/>
        </p:blipFill>
        <p:spPr>
          <a:xfrm>
            <a:off x="188259" y="1748593"/>
            <a:ext cx="11681025" cy="185522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13A4EE1-CE8F-6446-8141-9D40437E4F0E}"/>
              </a:ext>
            </a:extLst>
          </p:cNvPr>
          <p:cNvSpPr/>
          <p:nvPr/>
        </p:nvSpPr>
        <p:spPr>
          <a:xfrm>
            <a:off x="658905" y="4666131"/>
            <a:ext cx="1138519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7.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Induction of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-activated genes and lifespan of small RNA pathway-deficient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n heat-killed </a:t>
            </a:r>
            <a:r>
              <a:rPr lang="en-US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endParaRPr lang="en-US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eat-map of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-activated genes in wild-type N2 worms (bottom row) or immune pathway mutant worms (other horizontal rows) at steady-state (on heat-killed </a:t>
            </a:r>
            <a:r>
              <a:rPr lang="en-US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in the absence of infection). The heat-map reflects data from 2-3 biological replicates for each mutant analyzed. </a:t>
            </a:r>
          </a:p>
        </p:txBody>
      </p:sp>
    </p:spTree>
    <p:extLst>
      <p:ext uri="{BB962C8B-B14F-4D97-AF65-F5344CB8AC3E}">
        <p14:creationId xmlns:p14="http://schemas.microsoft.com/office/powerpoint/2010/main" val="28312854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F831569-AD38-E049-8FD1-D7C3790385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373"/>
          <a:stretch/>
        </p:blipFill>
        <p:spPr>
          <a:xfrm>
            <a:off x="1456766" y="33038"/>
            <a:ext cx="8722658" cy="5143802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14656AB-B02F-854F-B5D9-15537F65DA33}"/>
              </a:ext>
            </a:extLst>
          </p:cNvPr>
          <p:cNvSpPr/>
          <p:nvPr/>
        </p:nvSpPr>
        <p:spPr>
          <a:xfrm>
            <a:off x="425822" y="5176840"/>
            <a:ext cx="1142103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8.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Induction of 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-activated genes and lifespan of stress response pathway-deficient 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4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n heat-killed 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</a:p>
          <a:p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a)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eat-map of the fold-changes of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-activated genes in N2 worms treated with RNAi against stress response pathway components (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if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kgb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or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kn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 compared to vector control (L4440), fed heat-killed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coli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a non-pathogenic food source. The heat-map reflects data from 2-3 biological replicates for each mutant analyzed.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(b)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 Lifespan of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r-15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b26);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em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(hc17)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C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reated with L4440 vector control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kgb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if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r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kn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RNAi.  Results are representative of 3 independent assays. Statistically significant (p &lt; 0.05) survival curves relative to L4440 control are marked with an asterisk and bracket. Statistical significance of differences between survival curves was calculated using Kaplan-Meier log rank analysis.</a:t>
            </a:r>
          </a:p>
        </p:txBody>
      </p:sp>
    </p:spTree>
    <p:extLst>
      <p:ext uri="{BB962C8B-B14F-4D97-AF65-F5344CB8AC3E}">
        <p14:creationId xmlns:p14="http://schemas.microsoft.com/office/powerpoint/2010/main" val="13078633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871C1EE-93D1-CD4B-B4DA-141131C214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549" b="10392"/>
          <a:stretch/>
        </p:blipFill>
        <p:spPr>
          <a:xfrm>
            <a:off x="1333224" y="336177"/>
            <a:ext cx="8903369" cy="447787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E65445B-94C4-F344-A247-59C5584411EC}"/>
              </a:ext>
            </a:extLst>
          </p:cNvPr>
          <p:cNvSpPr/>
          <p:nvPr/>
        </p:nvSpPr>
        <p:spPr>
          <a:xfrm>
            <a:off x="559034" y="4913287"/>
            <a:ext cx="11139906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2F5496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 S9.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Correlation matrix of gene expression profiles of 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400" b="1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eficient in stress response and RNAi-related genes following </a:t>
            </a:r>
            <a:r>
              <a:rPr lang="en-US" sz="14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us</a:t>
            </a:r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infection</a:t>
            </a:r>
            <a:endParaRPr lang="en-US" sz="14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ierarchical clustering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endrogram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and a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eatmap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howing the color-coded pairwise correlation matrix for the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nCounter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gene expression profiles of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(vector control or RNAi knock-down; N2 or mutant) infected with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or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See legend of Fig S7 for details about the significance of the correlation values and interpretation of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endrogram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Among worms infected with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ali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, the immune pathway-deficient worms formed one cluster while the RNAi-treated worms formed a different, separate cluster; however, after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ecium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infection, worms deficient in small RNA processing and the stress response clustered more closely together, and were more dissimilar to the immune mutants and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hif-1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treated worms. The Pearson’s correlation coefficient for each </a:t>
            </a:r>
            <a:r>
              <a:rPr lang="en-US" sz="14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. </a:t>
            </a:r>
            <a:r>
              <a:rPr lang="en-US" sz="1400" i="1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legans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train and </a:t>
            </a:r>
            <a:r>
              <a:rPr lang="en-US" sz="14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nterococcal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species pair analyzed is shown. </a:t>
            </a:r>
          </a:p>
        </p:txBody>
      </p:sp>
    </p:spTree>
    <p:extLst>
      <p:ext uri="{BB962C8B-B14F-4D97-AF65-F5344CB8AC3E}">
        <p14:creationId xmlns:p14="http://schemas.microsoft.com/office/powerpoint/2010/main" val="1694897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312</Words>
  <Application>Microsoft Macintosh PowerPoint</Application>
  <PresentationFormat>Widescreen</PresentationFormat>
  <Paragraphs>20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en, Grace Jia-Li</dc:creator>
  <cp:lastModifiedBy>Yuen, Grace Jia-Li</cp:lastModifiedBy>
  <cp:revision>4</cp:revision>
  <dcterms:created xsi:type="dcterms:W3CDTF">2018-01-29T23:20:35Z</dcterms:created>
  <dcterms:modified xsi:type="dcterms:W3CDTF">2018-01-30T00:00:16Z</dcterms:modified>
</cp:coreProperties>
</file>